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343C9-E73D-42FD-A9BC-127F1023B8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52841-D70E-4DBE-8DDD-AE628522F2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9A844-71A2-4756-9BA9-E922C53300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F8E01-F1DA-4787-A18F-BBF99B6D62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D96F0-06E5-4623-B1C3-AAC0511340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AE66C-8A65-49D0-8BB1-55F85083AA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6E578-BE73-4814-A542-01F7F81FA3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8AFE0-298F-49A6-83FA-837F71C3F1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2ACC7-AC4A-48E6-8A84-70DB7B518E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940C3-4DC1-4C3B-9828-5042627DFD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C2BD1-8850-466E-8FE3-9CA7668A3D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FEA7D-345D-4062-887B-A7B72617C7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DB63E8-AFCC-4FB4-B894-E41C6092AF0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25360" y="2367000"/>
            <a:ext cx="4422600" cy="2122200"/>
            <a:chOff x="1125360" y="2367000"/>
            <a:chExt cx="4422600" cy="21222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3737" t="42254" r="9344" b="0"/>
            <a:stretch/>
          </p:blipFill>
          <p:spPr>
            <a:xfrm>
              <a:off x="1314360" y="3369240"/>
              <a:ext cx="4233600" cy="111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3742" t="9421" r="9355" b="47103"/>
            <a:stretch/>
          </p:blipFill>
          <p:spPr>
            <a:xfrm>
              <a:off x="1314360" y="2529360"/>
              <a:ext cx="4233600" cy="83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rcRect l="0" t="11776" r="95898" b="11776"/>
            <a:stretch/>
          </p:blipFill>
          <p:spPr>
            <a:xfrm>
              <a:off x="1125360" y="2696040"/>
              <a:ext cx="200520" cy="14796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5" name=""/>
            <p:cNvGrpSpPr/>
            <p:nvPr/>
          </p:nvGrpSpPr>
          <p:grpSpPr>
            <a:xfrm>
              <a:off x="5192640" y="3342240"/>
              <a:ext cx="287280" cy="53280"/>
              <a:chOff x="5192640" y="3342240"/>
              <a:chExt cx="287280" cy="53280"/>
            </a:xfrm>
          </p:grpSpPr>
          <p:sp>
            <p:nvSpPr>
              <p:cNvPr id="46" name=""/>
              <p:cNvSpPr/>
              <p:nvPr/>
            </p:nvSpPr>
            <p:spPr>
              <a:xfrm rot="21240000">
                <a:off x="5192640" y="3360600"/>
                <a:ext cx="286560" cy="158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 flipV="1">
                <a:off x="5195520" y="3342240"/>
                <a:ext cx="282240" cy="32040"/>
              </a:xfrm>
              <a:prstGeom prst="line">
                <a:avLst/>
              </a:prstGeom>
              <a:ln w="50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5197680" y="3364200"/>
                <a:ext cx="282240" cy="31320"/>
              </a:xfrm>
              <a:prstGeom prst="line">
                <a:avLst/>
              </a:prstGeom>
              <a:ln w="50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9" name=""/>
            <p:cNvGrpSpPr/>
            <p:nvPr/>
          </p:nvGrpSpPr>
          <p:grpSpPr>
            <a:xfrm>
              <a:off x="1485000" y="3351960"/>
              <a:ext cx="286560" cy="50400"/>
              <a:chOff x="1485000" y="3351960"/>
              <a:chExt cx="286560" cy="50400"/>
            </a:xfrm>
          </p:grpSpPr>
          <p:sp>
            <p:nvSpPr>
              <p:cNvPr id="50" name=""/>
              <p:cNvSpPr/>
              <p:nvPr/>
            </p:nvSpPr>
            <p:spPr>
              <a:xfrm rot="21240000">
                <a:off x="1485000" y="3366720"/>
                <a:ext cx="286560" cy="158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V="1">
                <a:off x="1492920" y="3367080"/>
                <a:ext cx="95760" cy="13680"/>
              </a:xfrm>
              <a:prstGeom prst="line">
                <a:avLst/>
              </a:prstGeom>
              <a:ln w="50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1494720" y="3388680"/>
                <a:ext cx="95760" cy="13680"/>
              </a:xfrm>
              <a:prstGeom prst="line">
                <a:avLst/>
              </a:prstGeom>
              <a:ln w="50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120" bIns="-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" name=""/>
            <p:cNvSpPr/>
            <p:nvPr/>
          </p:nvSpPr>
          <p:spPr>
            <a:xfrm>
              <a:off x="2764440" y="2367000"/>
              <a:ext cx="127512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900" spc="-1" strike="noStrike">
                  <a:solidFill>
                    <a:srgbClr val="000000"/>
                  </a:solidFill>
                  <a:latin typeface="Arial"/>
                </a:rPr>
                <a:t>Hypothalamu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"/>
          <p:cNvSpPr/>
          <p:nvPr/>
        </p:nvSpPr>
        <p:spPr>
          <a:xfrm>
            <a:off x="1341360" y="5084640"/>
            <a:ext cx="4321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Supplementary Figure S1. 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Quantitative RT-PCR expression in the hypothalamus of the identified Mecp2 target genes. White bars, wild-type mice: black bars, Mecp2 null mic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9T10:33:24Z</dcterms:created>
  <dc:creator>rgonzalezu</dc:creator>
  <dc:description/>
  <dc:language>en-US</dc:language>
  <cp:lastModifiedBy>h501xmeb</cp:lastModifiedBy>
  <dcterms:modified xsi:type="dcterms:W3CDTF">2008-10-22T08:08:25Z</dcterms:modified>
  <cp:revision>22</cp:revision>
  <dc:subject/>
  <dc:title>Diapositiva 1</dc:title>
</cp:coreProperties>
</file>